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16256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89678C-B03B-D7C7-9E7D-537426E1A2A7}" name="Malandrino, Noemi (NIH/NIDDK) [E]" initials="MN([" userId="S::malandrinon2@nih.gov::6200ecad-b2de-428a-8aa5-bb5ca7a5643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E13644-D5DB-4B92-A4D3-5CB16361942D}" v="25" dt="2025-04-13T22:27:10.3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89706" autoAdjust="0"/>
  </p:normalViewPr>
  <p:slideViewPr>
    <p:cSldViewPr snapToGrid="0">
      <p:cViewPr varScale="1">
        <p:scale>
          <a:sx n="86" d="100"/>
          <a:sy n="86" d="100"/>
        </p:scale>
        <p:origin x="3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ung, Stephanie (NIH/NIDDK) [E]" userId="67f14949-e182-4972-adac-385ab37da48c" providerId="ADAL" clId="{96E13644-D5DB-4B92-A4D3-5CB16361942D}"/>
    <pc:docChg chg="undo custSel addSld delSld modSld sldOrd modMainMaster">
      <pc:chgData name="Chung, Stephanie (NIH/NIDDK) [E]" userId="67f14949-e182-4972-adac-385ab37da48c" providerId="ADAL" clId="{96E13644-D5DB-4B92-A4D3-5CB16361942D}" dt="2025-04-13T22:29:25.908" v="309" actId="1037"/>
      <pc:docMkLst>
        <pc:docMk/>
      </pc:docMkLst>
      <pc:sldChg chg="del">
        <pc:chgData name="Chung, Stephanie (NIH/NIDDK) [E]" userId="67f14949-e182-4972-adac-385ab37da48c" providerId="ADAL" clId="{96E13644-D5DB-4B92-A4D3-5CB16361942D}" dt="2025-04-13T21:41:43.462" v="48" actId="47"/>
        <pc:sldMkLst>
          <pc:docMk/>
          <pc:sldMk cId="3185772121" sldId="256"/>
        </pc:sldMkLst>
      </pc:sldChg>
      <pc:sldChg chg="addSp modSp mod">
        <pc:chgData name="Chung, Stephanie (NIH/NIDDK) [E]" userId="67f14949-e182-4972-adac-385ab37da48c" providerId="ADAL" clId="{96E13644-D5DB-4B92-A4D3-5CB16361942D}" dt="2025-04-13T22:20:10.738" v="141" actId="20577"/>
        <pc:sldMkLst>
          <pc:docMk/>
          <pc:sldMk cId="339473622" sldId="257"/>
        </pc:sldMkLst>
        <pc:spChg chg="add mod">
          <ac:chgData name="Chung, Stephanie (NIH/NIDDK) [E]" userId="67f14949-e182-4972-adac-385ab37da48c" providerId="ADAL" clId="{96E13644-D5DB-4B92-A4D3-5CB16361942D}" dt="2025-04-13T22:20:10.738" v="141" actId="20577"/>
          <ac:spMkLst>
            <pc:docMk/>
            <pc:sldMk cId="339473622" sldId="257"/>
            <ac:spMk id="2" creationId="{9663693B-F55A-CDAC-C378-56CBA53D9DE4}"/>
          </ac:spMkLst>
        </pc:spChg>
        <pc:spChg chg="mod">
          <ac:chgData name="Chung, Stephanie (NIH/NIDDK) [E]" userId="67f14949-e182-4972-adac-385ab37da48c" providerId="ADAL" clId="{96E13644-D5DB-4B92-A4D3-5CB16361942D}" dt="2025-04-13T21:43:28.167" v="82" actId="1076"/>
          <ac:spMkLst>
            <pc:docMk/>
            <pc:sldMk cId="339473622" sldId="257"/>
            <ac:spMk id="7" creationId="{2B01782C-6E99-56BA-BA9C-F8C86198644E}"/>
          </ac:spMkLst>
        </pc:spChg>
        <pc:spChg chg="mod">
          <ac:chgData name="Chung, Stephanie (NIH/NIDDK) [E]" userId="67f14949-e182-4972-adac-385ab37da48c" providerId="ADAL" clId="{96E13644-D5DB-4B92-A4D3-5CB16361942D}" dt="2025-04-13T21:43:32.202" v="83" actId="1076"/>
          <ac:spMkLst>
            <pc:docMk/>
            <pc:sldMk cId="339473622" sldId="257"/>
            <ac:spMk id="8" creationId="{88E66ECA-B188-B356-44BE-250389158930}"/>
          </ac:spMkLst>
        </pc:spChg>
        <pc:spChg chg="mod">
          <ac:chgData name="Chung, Stephanie (NIH/NIDDK) [E]" userId="67f14949-e182-4972-adac-385ab37da48c" providerId="ADAL" clId="{96E13644-D5DB-4B92-A4D3-5CB16361942D}" dt="2025-04-13T21:42:56.783" v="62" actId="255"/>
          <ac:spMkLst>
            <pc:docMk/>
            <pc:sldMk cId="339473622" sldId="257"/>
            <ac:spMk id="9" creationId="{AD5D6E57-B7C1-369F-BE94-62265A311093}"/>
          </ac:spMkLst>
        </pc:spChg>
        <pc:spChg chg="mod">
          <ac:chgData name="Chung, Stephanie (NIH/NIDDK) [E]" userId="67f14949-e182-4972-adac-385ab37da48c" providerId="ADAL" clId="{96E13644-D5DB-4B92-A4D3-5CB16361942D}" dt="2025-04-13T21:42:56.783" v="62" actId="255"/>
          <ac:spMkLst>
            <pc:docMk/>
            <pc:sldMk cId="339473622" sldId="257"/>
            <ac:spMk id="10" creationId="{DDEF32CA-CBE9-3FD4-2607-30760EDF2981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1" creationId="{33728CDF-00A3-FEF2-2E96-71E548F96294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2" creationId="{3679A2E2-3C81-B8E8-C4C3-CA08E89FAD3A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3" creationId="{A311E4F1-3FAA-25B8-672C-5D788F62D610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4" creationId="{D120177A-BA0C-8DFE-9E14-243DFC8911FF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5" creationId="{EE26375E-52F1-73D6-A079-60EF75E85934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6" creationId="{6068CC3C-4E0B-068D-2635-B8A6BF614B57}"/>
          </ac:spMkLst>
        </pc:spChg>
        <pc:spChg chg="mod">
          <ac:chgData name="Chung, Stephanie (NIH/NIDDK) [E]" userId="67f14949-e182-4972-adac-385ab37da48c" providerId="ADAL" clId="{96E13644-D5DB-4B92-A4D3-5CB16361942D}" dt="2025-04-13T21:43:17.948" v="81" actId="1036"/>
          <ac:spMkLst>
            <pc:docMk/>
            <pc:sldMk cId="339473622" sldId="257"/>
            <ac:spMk id="17" creationId="{26971B49-9D11-A101-20D4-DE965E4A69CA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8" creationId="{38C0DB9D-95DD-1C98-FDF0-409C4F4930B0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9" creationId="{A6D07B09-94FA-1B0D-D262-48025339D386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20" creationId="{2AFCE003-8882-6603-BA06-10F182C699C3}"/>
          </ac:spMkLst>
        </pc:spChg>
        <pc:picChg chg="mod">
          <ac:chgData name="Chung, Stephanie (NIH/NIDDK) [E]" userId="67f14949-e182-4972-adac-385ab37da48c" providerId="ADAL" clId="{96E13644-D5DB-4B92-A4D3-5CB16361942D}" dt="2025-04-13T21:42:22.124" v="54" actId="14100"/>
          <ac:picMkLst>
            <pc:docMk/>
            <pc:sldMk cId="339473622" sldId="257"/>
            <ac:picMk id="5" creationId="{F2C1DD1C-A1AB-B702-9705-2628BA40E8D8}"/>
          </ac:picMkLst>
        </pc:picChg>
        <pc:picChg chg="mod">
          <ac:chgData name="Chung, Stephanie (NIH/NIDDK) [E]" userId="67f14949-e182-4972-adac-385ab37da48c" providerId="ADAL" clId="{96E13644-D5DB-4B92-A4D3-5CB16361942D}" dt="2025-04-13T21:42:22.124" v="54" actId="14100"/>
          <ac:picMkLst>
            <pc:docMk/>
            <pc:sldMk cId="339473622" sldId="257"/>
            <ac:picMk id="6" creationId="{428ECA73-FDFF-3B56-167D-5944DEC98D44}"/>
          </ac:picMkLst>
        </pc:picChg>
      </pc:sldChg>
      <pc:sldChg chg="addSp delSp modSp mod">
        <pc:chgData name="Chung, Stephanie (NIH/NIDDK) [E]" userId="67f14949-e182-4972-adac-385ab37da48c" providerId="ADAL" clId="{96E13644-D5DB-4B92-A4D3-5CB16361942D}" dt="2025-04-13T22:19:13.020" v="131" actId="1076"/>
        <pc:sldMkLst>
          <pc:docMk/>
          <pc:sldMk cId="3255338901" sldId="258"/>
        </pc:sldMkLst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2" creationId="{4F1DFA6D-46B5-F763-4FFB-A090A7268032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3" creationId="{F7910308-8AD5-D754-6BAB-DFCE8C09EC92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4" creationId="{B6EAE5FA-3298-231B-F92E-4533DF10EC0E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5" creationId="{997DBFC2-C7EB-4B0A-2381-07F1915F70CB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7" creationId="{377E8143-9E7B-F781-0A7C-DF668044A9EB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9" creationId="{01FA53AE-9E69-1DAE-B072-5E6BE10EC457}"/>
          </ac:spMkLst>
        </pc:spChg>
        <pc:spChg chg="add mod">
          <ac:chgData name="Chung, Stephanie (NIH/NIDDK) [E]" userId="67f14949-e182-4972-adac-385ab37da48c" providerId="ADAL" clId="{96E13644-D5DB-4B92-A4D3-5CB16361942D}" dt="2025-04-13T22:09:24.738" v="123" actId="20577"/>
          <ac:spMkLst>
            <pc:docMk/>
            <pc:sldMk cId="3255338901" sldId="258"/>
            <ac:spMk id="10" creationId="{494926D4-8067-46B2-1352-604AF5887EBF}"/>
          </ac:spMkLst>
        </pc:spChg>
        <pc:graphicFrameChg chg="add mod">
          <ac:chgData name="Chung, Stephanie (NIH/NIDDK) [E]" userId="67f14949-e182-4972-adac-385ab37da48c" providerId="ADAL" clId="{96E13644-D5DB-4B92-A4D3-5CB16361942D}" dt="2025-04-13T22:19:13.020" v="131" actId="1076"/>
          <ac:graphicFrameMkLst>
            <pc:docMk/>
            <pc:sldMk cId="3255338901" sldId="258"/>
            <ac:graphicFrameMk id="11" creationId="{B2010027-5A62-59EA-33D1-6999ED943C4C}"/>
          </ac:graphicFrameMkLst>
        </pc:graphicFrameChg>
        <pc:picChg chg="del mod">
          <ac:chgData name="Chung, Stephanie (NIH/NIDDK) [E]" userId="67f14949-e182-4972-adac-385ab37da48c" providerId="ADAL" clId="{96E13644-D5DB-4B92-A4D3-5CB16361942D}" dt="2025-04-13T22:18:25.798" v="126" actId="478"/>
          <ac:picMkLst>
            <pc:docMk/>
            <pc:sldMk cId="3255338901" sldId="258"/>
            <ac:picMk id="6" creationId="{3B779D81-A94C-6F86-259D-66A6FBDCA152}"/>
          </ac:picMkLst>
        </pc:picChg>
        <pc:picChg chg="del mod">
          <ac:chgData name="Chung, Stephanie (NIH/NIDDK) [E]" userId="67f14949-e182-4972-adac-385ab37da48c" providerId="ADAL" clId="{96E13644-D5DB-4B92-A4D3-5CB16361942D}" dt="2025-04-13T22:18:25.798" v="126" actId="478"/>
          <ac:picMkLst>
            <pc:docMk/>
            <pc:sldMk cId="3255338901" sldId="258"/>
            <ac:picMk id="8" creationId="{5BF5214B-23BF-DEE8-298A-610B21825B13}"/>
          </ac:picMkLst>
        </pc:picChg>
        <pc:picChg chg="del">
          <ac:chgData name="Chung, Stephanie (NIH/NIDDK) [E]" userId="67f14949-e182-4972-adac-385ab37da48c" providerId="ADAL" clId="{96E13644-D5DB-4B92-A4D3-5CB16361942D}" dt="2025-04-13T21:41:28.568" v="45" actId="478"/>
          <ac:picMkLst>
            <pc:docMk/>
            <pc:sldMk cId="3255338901" sldId="258"/>
            <ac:picMk id="13" creationId="{CE7A8BDB-9279-CF89-1E96-103EA7A43530}"/>
          </ac:picMkLst>
        </pc:picChg>
        <pc:picChg chg="del">
          <ac:chgData name="Chung, Stephanie (NIH/NIDDK) [E]" userId="67f14949-e182-4972-adac-385ab37da48c" providerId="ADAL" clId="{96E13644-D5DB-4B92-A4D3-5CB16361942D}" dt="2025-04-13T21:41:28.568" v="45" actId="478"/>
          <ac:picMkLst>
            <pc:docMk/>
            <pc:sldMk cId="3255338901" sldId="258"/>
            <ac:picMk id="17" creationId="{8337F1A9-20B3-3FA9-81FD-DEA1A33E49F3}"/>
          </ac:picMkLst>
        </pc:picChg>
      </pc:sldChg>
      <pc:sldChg chg="addSp delSp modSp mod">
        <pc:chgData name="Chung, Stephanie (NIH/NIDDK) [E]" userId="67f14949-e182-4972-adac-385ab37da48c" providerId="ADAL" clId="{96E13644-D5DB-4B92-A4D3-5CB16361942D}" dt="2025-04-13T22:09:01.945" v="121" actId="1076"/>
        <pc:sldMkLst>
          <pc:docMk/>
          <pc:sldMk cId="728344467" sldId="259"/>
        </pc:sldMkLst>
        <pc:spChg chg="add mod">
          <ac:chgData name="Chung, Stephanie (NIH/NIDDK) [E]" userId="67f14949-e182-4972-adac-385ab37da48c" providerId="ADAL" clId="{96E13644-D5DB-4B92-A4D3-5CB16361942D}" dt="2025-04-13T22:08:41.186" v="114" actId="255"/>
          <ac:spMkLst>
            <pc:docMk/>
            <pc:sldMk cId="728344467" sldId="259"/>
            <ac:spMk id="2" creationId="{86D32E72-BA05-19C8-3730-9BB54D49831C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3" creationId="{C9A0BC4A-7397-90D2-5647-9BCF70BF4F12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4" creationId="{E66AE62F-7145-77D2-B3B7-2C3BA315AE05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5" creationId="{6C57F537-653C-4547-407E-10F46CF3C9F6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6" creationId="{043134A2-DC41-6F88-FAA6-D9E623378E3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7" creationId="{9AE3C775-B579-ACF0-A211-9D5DE2DD0AD3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9" creationId="{DF0C8EEE-347C-73A4-9C64-9C4D5E7B065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11" creationId="{AEA0C8C8-B0E3-7F99-26BB-6A7D0B1ADDD7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13" creationId="{348EA720-ED02-16F5-6C1E-072034BD2AAC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2" creationId="{29DE41E2-DBB5-08C9-5A6C-10FD872C36AB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3" creationId="{A8E1D8F2-EE0C-F441-9FF0-7EFD3210D6F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4" creationId="{B7E661E9-CE80-5434-FD87-00BE1E1C3B05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5" creationId="{0D24159A-E4EC-88C2-D7BA-F8163B2DEBE1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6" creationId="{E01FB4FD-7030-34C2-D779-31BB689CDCF6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7" creationId="{EB224A1C-0C1C-9E25-A3DF-B3E0EF045CEA}"/>
          </ac:spMkLst>
        </pc:spChg>
        <pc:graphicFrameChg chg="add mod">
          <ac:chgData name="Chung, Stephanie (NIH/NIDDK) [E]" userId="67f14949-e182-4972-adac-385ab37da48c" providerId="ADAL" clId="{96E13644-D5DB-4B92-A4D3-5CB16361942D}" dt="2025-04-13T22:09:01.945" v="121" actId="1076"/>
          <ac:graphicFrameMkLst>
            <pc:docMk/>
            <pc:sldMk cId="728344467" sldId="259"/>
            <ac:graphicFrameMk id="8" creationId="{730C7FC8-C9E5-0A1E-84D5-AD8C106B899F}"/>
          </ac:graphicFrameMkLst>
        </pc:graphicFrame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6" creationId="{FF08F6D5-28E9-FEE4-A681-040F0F382221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8" creationId="{514AC18E-0BAF-6FCA-1F0D-F5F228F56B62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9" creationId="{23D5E313-78F2-7DEB-7377-DA5676F13EEE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20" creationId="{57D048D6-ABD2-5180-F47A-0EFA29BBF2B4}"/>
          </ac:picMkLst>
        </pc:picChg>
      </pc:sldChg>
      <pc:sldChg chg="addSp delSp modSp mod modNotes">
        <pc:chgData name="Chung, Stephanie (NIH/NIDDK) [E]" userId="67f14949-e182-4972-adac-385ab37da48c" providerId="ADAL" clId="{96E13644-D5DB-4B92-A4D3-5CB16361942D}" dt="2025-04-13T22:29:25.908" v="309" actId="1037"/>
        <pc:sldMkLst>
          <pc:docMk/>
          <pc:sldMk cId="690432234" sldId="260"/>
        </pc:sldMkLst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" creationId="{46E9FF08-93F2-330E-E2E3-5A1C8F0F777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" creationId="{ACA969A6-1D0C-CB22-3A90-907B430FEBDA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5" creationId="{3403A9D2-5C86-AB5F-961E-B4F5745B79FA}"/>
          </ac:spMkLst>
        </pc:spChg>
        <pc:spChg chg="add mod">
          <ac:chgData name="Chung, Stephanie (NIH/NIDDK) [E]" userId="67f14949-e182-4972-adac-385ab37da48c" providerId="ADAL" clId="{96E13644-D5DB-4B92-A4D3-5CB16361942D}" dt="2025-04-13T22:20:00.152" v="132"/>
          <ac:spMkLst>
            <pc:docMk/>
            <pc:sldMk cId="690432234" sldId="260"/>
            <ac:spMk id="7" creationId="{08C9EAB6-6DFD-B2B6-EAFC-92AC7D5BADE0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8" creationId="{4276CB35-1E4B-BA3A-354B-EA62FC3F9C0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9" creationId="{91D98B5A-B031-4558-346C-0FD46894425D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11" creationId="{ED98F24D-15E0-C877-3230-803608C7235F}"/>
          </ac:spMkLst>
        </pc:spChg>
        <pc:spChg chg="add mod">
          <ac:chgData name="Chung, Stephanie (NIH/NIDDK) [E]" userId="67f14949-e182-4972-adac-385ab37da48c" providerId="ADAL" clId="{96E13644-D5DB-4B92-A4D3-5CB16361942D}" dt="2025-04-13T22:28:28.831" v="295" actId="14100"/>
          <ac:spMkLst>
            <pc:docMk/>
            <pc:sldMk cId="690432234" sldId="260"/>
            <ac:spMk id="13" creationId="{76642B76-81D1-E8A8-7166-2A64F75224F6}"/>
          </ac:spMkLst>
        </pc:spChg>
        <pc:spChg chg="mod">
          <ac:chgData name="Chung, Stephanie (NIH/NIDDK) [E]" userId="67f14949-e182-4972-adac-385ab37da48c" providerId="ADAL" clId="{96E13644-D5DB-4B92-A4D3-5CB16361942D}" dt="2025-04-13T22:28:48.916" v="297" actId="14100"/>
          <ac:spMkLst>
            <pc:docMk/>
            <pc:sldMk cId="690432234" sldId="260"/>
            <ac:spMk id="15" creationId="{566C72E2-7FEC-C7F9-B9CA-FB775AA3B174}"/>
          </ac:spMkLst>
        </pc:spChg>
        <pc:spChg chg="mod">
          <ac:chgData name="Chung, Stephanie (NIH/NIDDK) [E]" userId="67f14949-e182-4972-adac-385ab37da48c" providerId="ADAL" clId="{96E13644-D5DB-4B92-A4D3-5CB16361942D}" dt="2025-04-13T22:28:54.029" v="298" actId="14100"/>
          <ac:spMkLst>
            <pc:docMk/>
            <pc:sldMk cId="690432234" sldId="260"/>
            <ac:spMk id="18" creationId="{AF115EC8-EBAD-3A00-2149-CA9825852BF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1" creationId="{6A51F51A-787B-3C68-F473-F7EA3C5353F9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2" creationId="{C545EAC8-54EC-CA16-BE2A-9B082AA5469B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3" creationId="{2BADAADD-739C-7ADB-3FEF-C2B5E7E1874E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7" creationId="{22A19288-2202-63B6-9AF6-F64493764D1F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8" creationId="{25FE3C21-2959-676A-F4A3-BCBDA3968049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9" creationId="{D5FB9886-EDF5-A2C8-F2E5-939E3CC651EA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35" creationId="{3A2641FE-EFCD-CFD7-4723-3AC24412B8CF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4" creationId="{F3AB4C42-3FBA-0E3F-4541-76F763E273D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5" creationId="{79EBE262-F98C-196D-2AB4-EACB81F99C43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6" creationId="{1CAC2F22-A239-7F74-A9DB-039877E37D41}"/>
          </ac:spMkLst>
        </pc:spChg>
        <pc:spChg chg="mod">
          <ac:chgData name="Chung, Stephanie (NIH/NIDDK) [E]" userId="67f14949-e182-4972-adac-385ab37da48c" providerId="ADAL" clId="{96E13644-D5DB-4B92-A4D3-5CB16361942D}" dt="2025-04-13T22:29:03.753" v="299" actId="207"/>
          <ac:spMkLst>
            <pc:docMk/>
            <pc:sldMk cId="690432234" sldId="260"/>
            <ac:spMk id="47" creationId="{F88C1250-F20F-C412-0D9E-2E3C05C111AB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49" creationId="{C67BE316-C560-E952-24C2-A2AB2D35FAD5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2" creationId="{AD0D1B7C-E015-38CA-9E0D-0830D1CEAD41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7" creationId="{C3F66D08-04FC-B450-45D6-D5EAB784F035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8" creationId="{026650E4-C6A4-2082-4D3A-D1D8826C406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9" creationId="{885630B4-6ECE-67C3-6957-187379B017B0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60" creationId="{986757F1-CB49-3851-5C51-5BAC0E96E8D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62" creationId="{CA4A2F3C-0FED-0C31-DB5E-45C75C2BCAFD}"/>
          </ac:spMkLst>
        </pc:spChg>
        <pc:spChg chg="del mod">
          <ac:chgData name="Chung, Stephanie (NIH/NIDDK) [E]" userId="67f14949-e182-4972-adac-385ab37da48c" providerId="ADAL" clId="{96E13644-D5DB-4B92-A4D3-5CB16361942D}" dt="2025-04-13T22:29:08.842" v="300" actId="478"/>
          <ac:spMkLst>
            <pc:docMk/>
            <pc:sldMk cId="690432234" sldId="260"/>
            <ac:spMk id="64" creationId="{17D2BA5B-B799-2B8B-B2F2-588E65AD3C08}"/>
          </ac:spMkLst>
        </pc:spChg>
        <pc:spChg chg="del mod">
          <ac:chgData name="Chung, Stephanie (NIH/NIDDK) [E]" userId="67f14949-e182-4972-adac-385ab37da48c" providerId="ADAL" clId="{96E13644-D5DB-4B92-A4D3-5CB16361942D}" dt="2025-04-13T22:26:38.912" v="275" actId="478"/>
          <ac:spMkLst>
            <pc:docMk/>
            <pc:sldMk cId="690432234" sldId="260"/>
            <ac:spMk id="65" creationId="{3E996400-C06A-8EFA-4291-E4F788023A2B}"/>
          </ac:spMkLst>
        </pc:spChg>
        <pc:spChg chg="del mod">
          <ac:chgData name="Chung, Stephanie (NIH/NIDDK) [E]" userId="67f14949-e182-4972-adac-385ab37da48c" providerId="ADAL" clId="{96E13644-D5DB-4B92-A4D3-5CB16361942D}" dt="2025-04-13T22:27:21.204" v="284" actId="478"/>
          <ac:spMkLst>
            <pc:docMk/>
            <pc:sldMk cId="690432234" sldId="260"/>
            <ac:spMk id="66" creationId="{79E49986-689B-4BBE-D063-38283C922BFD}"/>
          </ac:spMkLst>
        </pc:spChg>
        <pc:grpChg chg="add mod">
          <ac:chgData name="Chung, Stephanie (NIH/NIDDK) [E]" userId="67f14949-e182-4972-adac-385ab37da48c" providerId="ADAL" clId="{96E13644-D5DB-4B92-A4D3-5CB16361942D}" dt="2025-04-13T22:29:25.908" v="309" actId="1037"/>
          <ac:grpSpMkLst>
            <pc:docMk/>
            <pc:sldMk cId="690432234" sldId="260"/>
            <ac:grpSpMk id="24" creationId="{972DEA50-E807-8B8C-D9C2-33BC8D801E0E}"/>
          </ac:grpSpMkLst>
        </pc:grpChg>
        <pc:cxnChg chg="mod">
          <ac:chgData name="Chung, Stephanie (NIH/NIDDK) [E]" userId="67f14949-e182-4972-adac-385ab37da48c" providerId="ADAL" clId="{96E13644-D5DB-4B92-A4D3-5CB16361942D}" dt="2025-04-13T22:23:44.322" v="193" actId="1076"/>
          <ac:cxnSpMkLst>
            <pc:docMk/>
            <pc:sldMk cId="690432234" sldId="260"/>
            <ac:cxnSpMk id="3" creationId="{5C5E694F-6921-8F2C-7546-EC535AB8308C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" creationId="{CB1A43BD-B14F-ABB1-C203-2B120AEF4065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0" creationId="{FAFE3D17-AC5B-31C4-B572-D9F6F121BD3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2" creationId="{5A922433-DC30-C429-2167-7EEAEE5BA995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4" creationId="{2F6C0D07-0B5A-C66E-A398-D989C7194096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6" creationId="{9988496A-D1FC-A24D-AF10-45D1085592E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7" creationId="{EAC149DF-668E-6B2B-89DF-E5AFBBC33570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9" creationId="{874074D1-7586-885D-82D7-499E5C34B15F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20" creationId="{B67DDECA-3B59-0DA2-9DDA-CA58C704B26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4" creationId="{244AD61D-700D-A0A0-0FEC-CCDE038DD99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6" creationId="{60C8D935-280F-87F2-66BE-21ECC4DD35F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7" creationId="{6213AE5A-72F2-6A67-2D74-FCCCB886E2DF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0" creationId="{AE2F9DBD-FC0E-0ED1-15B2-57B28DDEFF00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3" creationId="{08B5A42C-625C-8F99-2024-3D31D50B79E2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8" creationId="{CDAD4BFB-A893-8CE4-D150-DC74E425CA2A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0" creationId="{F6C961E9-5771-BBC4-0804-8DF7733EB188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1" creationId="{68DE962C-043E-5494-D537-CC2AA35BBA99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3" creationId="{9CE38A8A-BDCD-F13F-0DC7-A202F30E9EE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4" creationId="{D87A7B3E-EC1B-0F66-2FE8-8684D6B4674E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5" creationId="{30B377D3-4EA5-B68C-9760-EEDF40E93C5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6" creationId="{B388D2AA-4C05-827D-6E15-0957E78EF3B3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1" creationId="{217B282A-99E2-4B62-050C-68EC0D9018AD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3" creationId="{C14C7FE3-88C4-7453-43D2-C358DBFB762A}"/>
          </ac:cxnSpMkLst>
        </pc:cxnChg>
      </pc:sldChg>
      <pc:sldChg chg="add del ord">
        <pc:chgData name="Chung, Stephanie (NIH/NIDDK) [E]" userId="67f14949-e182-4972-adac-385ab37da48c" providerId="ADAL" clId="{96E13644-D5DB-4B92-A4D3-5CB16361942D}" dt="2025-04-13T22:18:28.087" v="127" actId="47"/>
        <pc:sldMkLst>
          <pc:docMk/>
          <pc:sldMk cId="1127047379" sldId="260"/>
        </pc:sldMkLst>
      </pc:sldChg>
      <pc:sldMasterChg chg="modSp modSldLayout">
        <pc:chgData name="Chung, Stephanie (NIH/NIDDK) [E]" userId="67f14949-e182-4972-adac-385ab37da48c" providerId="ADAL" clId="{96E13644-D5DB-4B92-A4D3-5CB16361942D}" dt="2025-04-13T21:41:55.401" v="49"/>
        <pc:sldMasterMkLst>
          <pc:docMk/>
          <pc:sldMasterMk cId="3978593516" sldId="2147483660"/>
        </pc:sldMasterMkLst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2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3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4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5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6" creationId="{00000000-0000-0000-0000-000000000000}"/>
          </ac:spMkLst>
        </pc:sp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072920937" sldId="2147483661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072920937" sldId="2147483661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072920937" sldId="2147483661"/>
              <ac:spMk id="3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2026823514" sldId="2147483663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026823514" sldId="2147483663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026823514" sldId="2147483663"/>
              <ac:spMk id="3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1924428051" sldId="2147483664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1924428051" sldId="2147483664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1924428051" sldId="2147483664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183848783" sldId="2147483665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4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5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6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760612395" sldId="2147483668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2650198897" sldId="2147483669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811725813" sldId="2147483671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811725813" sldId="2147483671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811725813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3B1A0-A823-4EC1-843E-1032505B1D7E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F9A92-81B3-43A6-B9DA-598E7A917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861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17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98A8A7B-AABC-42E0-B572-F19A6C4C3882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17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44503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496484"/>
            <a:ext cx="13817600" cy="3183468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8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8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2"/>
            </a:lvl4pPr>
            <a:lvl5pPr marL="2438339" indent="0" algn="ctr">
              <a:buNone/>
              <a:defRPr sz="2132"/>
            </a:lvl5pPr>
            <a:lvl6pPr marL="3047924" indent="0" algn="ctr">
              <a:buNone/>
              <a:defRPr sz="2132"/>
            </a:lvl6pPr>
            <a:lvl7pPr marL="3657509" indent="0" algn="ctr">
              <a:buNone/>
              <a:defRPr sz="2132"/>
            </a:lvl7pPr>
            <a:lvl8pPr marL="4267093" indent="0" algn="ctr">
              <a:buNone/>
              <a:defRPr sz="2132"/>
            </a:lvl8pPr>
            <a:lvl9pPr marL="4876678" indent="0" algn="ctr">
              <a:buNone/>
              <a:defRPr sz="213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902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274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486834"/>
            <a:ext cx="3505201" cy="774911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2" y="486834"/>
            <a:ext cx="10312401" cy="774911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543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088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2279655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6119288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8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396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2434168"/>
            <a:ext cx="69088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2434168"/>
            <a:ext cx="69088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519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486836"/>
            <a:ext cx="14020800" cy="17674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241553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8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2" b="1"/>
            </a:lvl4pPr>
            <a:lvl5pPr marL="2438339" indent="0">
              <a:buNone/>
              <a:defRPr sz="2132" b="1"/>
            </a:lvl5pPr>
            <a:lvl6pPr marL="3047924" indent="0">
              <a:buNone/>
              <a:defRPr sz="2132" b="1"/>
            </a:lvl6pPr>
            <a:lvl7pPr marL="3657509" indent="0">
              <a:buNone/>
              <a:defRPr sz="2132" b="1"/>
            </a:lvl7pPr>
            <a:lvl8pPr marL="4267093" indent="0">
              <a:buNone/>
              <a:defRPr sz="2132" b="1"/>
            </a:lvl8pPr>
            <a:lvl9pPr marL="4876678" indent="0">
              <a:buNone/>
              <a:defRPr sz="213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3340101"/>
            <a:ext cx="687704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3" y="2241553"/>
            <a:ext cx="691091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8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2" b="1"/>
            </a:lvl4pPr>
            <a:lvl5pPr marL="2438339" indent="0">
              <a:buNone/>
              <a:defRPr sz="2132" b="1"/>
            </a:lvl5pPr>
            <a:lvl6pPr marL="3047924" indent="0">
              <a:buNone/>
              <a:defRPr sz="2132" b="1"/>
            </a:lvl6pPr>
            <a:lvl7pPr marL="3657509" indent="0">
              <a:buNone/>
              <a:defRPr sz="2132" b="1"/>
            </a:lvl7pPr>
            <a:lvl8pPr marL="4267093" indent="0">
              <a:buNone/>
              <a:defRPr sz="2132" b="1"/>
            </a:lvl8pPr>
            <a:lvl9pPr marL="4876678" indent="0">
              <a:buNone/>
              <a:defRPr sz="213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3" y="3340101"/>
            <a:ext cx="69109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792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659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44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0" y="609600"/>
            <a:ext cx="5242983" cy="2133600"/>
          </a:xfrm>
        </p:spPr>
        <p:txBody>
          <a:bodyPr anchor="b"/>
          <a:lstStyle>
            <a:lvl1pPr>
              <a:defRPr sz="4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20" y="1316569"/>
            <a:ext cx="8229600" cy="6498168"/>
          </a:xfrm>
        </p:spPr>
        <p:txBody>
          <a:bodyPr/>
          <a:lstStyle>
            <a:lvl1pPr>
              <a:defRPr sz="4268"/>
            </a:lvl1pPr>
            <a:lvl2pPr>
              <a:defRPr sz="3733"/>
            </a:lvl2pPr>
            <a:lvl3pPr>
              <a:defRPr sz="3200"/>
            </a:lvl3pPr>
            <a:lvl4pPr>
              <a:defRPr sz="2668"/>
            </a:lvl4pPr>
            <a:lvl5pPr>
              <a:defRPr sz="2668"/>
            </a:lvl5pPr>
            <a:lvl6pPr>
              <a:defRPr sz="2668"/>
            </a:lvl6pPr>
            <a:lvl7pPr>
              <a:defRPr sz="2668"/>
            </a:lvl7pPr>
            <a:lvl8pPr>
              <a:defRPr sz="2668"/>
            </a:lvl8pPr>
            <a:lvl9pPr>
              <a:defRPr sz="26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0" y="2743200"/>
            <a:ext cx="5242983" cy="5082118"/>
          </a:xfrm>
        </p:spPr>
        <p:txBody>
          <a:bodyPr/>
          <a:lstStyle>
            <a:lvl1pPr marL="0" indent="0">
              <a:buNone/>
              <a:defRPr sz="2132"/>
            </a:lvl1pPr>
            <a:lvl2pPr marL="609585" indent="0">
              <a:buNone/>
              <a:defRPr sz="1868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971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0" y="609600"/>
            <a:ext cx="5242983" cy="2133600"/>
          </a:xfrm>
        </p:spPr>
        <p:txBody>
          <a:bodyPr anchor="b"/>
          <a:lstStyle>
            <a:lvl1pPr>
              <a:defRPr sz="4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20" y="1316569"/>
            <a:ext cx="8229600" cy="6498168"/>
          </a:xfrm>
        </p:spPr>
        <p:txBody>
          <a:bodyPr anchor="t"/>
          <a:lstStyle>
            <a:lvl1pPr marL="0" indent="0">
              <a:buNone/>
              <a:defRPr sz="4268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8"/>
            </a:lvl4pPr>
            <a:lvl5pPr marL="2438339" indent="0">
              <a:buNone/>
              <a:defRPr sz="2668"/>
            </a:lvl5pPr>
            <a:lvl6pPr marL="3047924" indent="0">
              <a:buNone/>
              <a:defRPr sz="2668"/>
            </a:lvl6pPr>
            <a:lvl7pPr marL="3657509" indent="0">
              <a:buNone/>
              <a:defRPr sz="2668"/>
            </a:lvl7pPr>
            <a:lvl8pPr marL="4267093" indent="0">
              <a:buNone/>
              <a:defRPr sz="2668"/>
            </a:lvl8pPr>
            <a:lvl9pPr marL="4876678" indent="0">
              <a:buNone/>
              <a:defRPr sz="26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0" y="2743200"/>
            <a:ext cx="5242983" cy="5082118"/>
          </a:xfrm>
        </p:spPr>
        <p:txBody>
          <a:bodyPr/>
          <a:lstStyle>
            <a:lvl1pPr marL="0" indent="0">
              <a:buNone/>
              <a:defRPr sz="2132"/>
            </a:lvl1pPr>
            <a:lvl2pPr marL="609585" indent="0">
              <a:buNone/>
              <a:defRPr sz="1868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53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486836"/>
            <a:ext cx="14020800" cy="17674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2434168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8475137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FE3FC-D7FE-41B8-A9BE-958B27DAB954}" type="datetimeFigureOut">
              <a:rPr lang="en-US" smtClean="0"/>
              <a:t>7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8475137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8475137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1B82A-75B2-4B17-86A7-8A539B965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824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3" indent="-304793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8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3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668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8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3" algn="l" defTabSz="1219170" rtl="0" eaLnBrk="1" latinLnBrk="0" hangingPunct="1">
        <a:lnSpc>
          <a:spcPct val="90000"/>
        </a:lnSpc>
        <a:spcBef>
          <a:spcPts val="668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972DEA50-E807-8B8C-D9C2-33BC8D801E0E}"/>
              </a:ext>
            </a:extLst>
          </p:cNvPr>
          <p:cNvGrpSpPr/>
          <p:nvPr/>
        </p:nvGrpSpPr>
        <p:grpSpPr>
          <a:xfrm>
            <a:off x="2906941" y="868024"/>
            <a:ext cx="13556665" cy="6939957"/>
            <a:chOff x="3756267" y="249852"/>
            <a:chExt cx="9083141" cy="5995463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CB1A43BD-B14F-ABB1-C203-2B120AEF4065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296485" y="1917430"/>
              <a:ext cx="6635186" cy="3423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" name="Rectangle: Rounded Corners 1">
              <a:extLst>
                <a:ext uri="{FF2B5EF4-FFF2-40B4-BE49-F238E27FC236}">
                  <a16:creationId xmlns:a16="http://schemas.microsoft.com/office/drawing/2014/main" id="{46E9FF08-93F2-330E-E2E3-5A1C8F0F777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501550" y="249852"/>
              <a:ext cx="2223116" cy="373169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Sample (n=1,862)</a:t>
              </a:r>
            </a:p>
          </p:txBody>
        </p: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5C5E694F-6921-8F2C-7546-EC535AB8308C}"/>
                </a:ext>
              </a:extLst>
            </p:cNvPr>
            <p:cNvCxnSpPr>
              <a:cxnSpLocks noChangeAspect="1"/>
              <a:stCxn id="2" idx="2"/>
              <a:endCxn id="8" idx="0"/>
            </p:cNvCxnSpPr>
            <p:nvPr/>
          </p:nvCxnSpPr>
          <p:spPr>
            <a:xfrm>
              <a:off x="7613108" y="623021"/>
              <a:ext cx="972" cy="108498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ACA969A6-1D0C-CB22-3A90-907B430FEBD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57239" y="1699685"/>
              <a:ext cx="1750715" cy="514350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althy Lean </a:t>
              </a:r>
            </a:p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685</a:t>
              </a:r>
            </a:p>
          </p:txBody>
        </p:sp>
        <p:sp>
          <p:nvSpPr>
            <p:cNvPr id="5" name="Rectangle: Rounded Corners 4">
              <a:extLst>
                <a:ext uri="{FF2B5EF4-FFF2-40B4-BE49-F238E27FC236}">
                  <a16:creationId xmlns:a16="http://schemas.microsoft.com/office/drawing/2014/main" id="{3403A9D2-5C86-AB5F-961E-B4F5745B79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20207" y="1698646"/>
              <a:ext cx="1750715" cy="506034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-T2D</a:t>
              </a:r>
            </a:p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97</a:t>
              </a:r>
            </a:p>
          </p:txBody>
        </p:sp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4276CB35-1E4B-BA3A-354B-EA62FC3F9C0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738722" y="1708002"/>
              <a:ext cx="1750715" cy="506035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W/OB </a:t>
              </a:r>
            </a:p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98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1D98B5A-B031-4558-346C-0FD46894425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724792" y="674397"/>
              <a:ext cx="1691391" cy="9306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Sites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IDDK (n=393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ICHD (n=1,321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CHOP (n=155)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FAFE3D17-AC5B-31C4-B572-D9F6F121BD3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73204" y="2214034"/>
              <a:ext cx="2329" cy="111568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D98F24D-15E0-C877-3230-803608C7235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890355" y="2335061"/>
              <a:ext cx="2035039" cy="93061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Age &gt; 25 years (n=34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Duplicate participants (n=0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24)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5A922433-DC30-C429-2167-7EEAEE5BA995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82862" y="2724746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2F6C0D07-0B5A-C66E-A398-D989C7194096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15050" y="2214034"/>
              <a:ext cx="2329" cy="111568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66C72E2-7FEC-C7F9-B9CA-FB775AA3B17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832207" y="2284565"/>
              <a:ext cx="1930547" cy="93061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Age &gt; 25 years (n=129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Duplicate participants (n=2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52)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988496A-D1FC-A24D-AF10-45D1085592E7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24711" y="2724746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EAC149DF-668E-6B2B-89DF-E5AFBBC33570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596534" y="2214034"/>
              <a:ext cx="2329" cy="111568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F115EC8-EBAD-3A00-2149-CA9825852BF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0790624" y="2325165"/>
              <a:ext cx="2048784" cy="93061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Age &gt; 25 years (n=20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Duplicate participants (n=51)</a:t>
              </a: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9)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874074D1-7586-885D-82D7-499E5C34B15F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606194" y="2724746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B67DDECA-3B59-0DA2-9DDA-CA58C704B26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295515" y="3553185"/>
              <a:ext cx="6635186" cy="3423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Rectangle: Rounded Corners 20">
              <a:extLst>
                <a:ext uri="{FF2B5EF4-FFF2-40B4-BE49-F238E27FC236}">
                  <a16:creationId xmlns:a16="http://schemas.microsoft.com/office/drawing/2014/main" id="{6A51F51A-787B-3C68-F473-F7EA3C5353F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56269" y="3335439"/>
              <a:ext cx="1750715" cy="514350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627</a:t>
              </a:r>
            </a:p>
          </p:txBody>
        </p:sp>
        <p:sp>
          <p:nvSpPr>
            <p:cNvPr id="22" name="Rectangle: Rounded Corners 21">
              <a:extLst>
                <a:ext uri="{FF2B5EF4-FFF2-40B4-BE49-F238E27FC236}">
                  <a16:creationId xmlns:a16="http://schemas.microsoft.com/office/drawing/2014/main" id="{C545EAC8-54EC-CA16-BE2A-9B082AA5469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19237" y="3334402"/>
              <a:ext cx="1750715" cy="50603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17</a:t>
              </a:r>
            </a:p>
          </p:txBody>
        </p:sp>
        <p:sp>
          <p:nvSpPr>
            <p:cNvPr id="23" name="Rectangle: Rounded Corners 22">
              <a:extLst>
                <a:ext uri="{FF2B5EF4-FFF2-40B4-BE49-F238E27FC236}">
                  <a16:creationId xmlns:a16="http://schemas.microsoft.com/office/drawing/2014/main" id="{2BADAADD-739C-7ADB-3FEF-C2B5E7E1874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737752" y="3343757"/>
              <a:ext cx="1750715" cy="506035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803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244AD61D-700D-A0A0-0FEC-CCDE038DD997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73204" y="3840434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A2641FE-EFCD-CFD7-4723-3AC24412B8C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875692" y="3946163"/>
              <a:ext cx="1495104" cy="71790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567)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60C8D935-280F-87F2-66BE-21ECC4DD35F7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75527" y="4180959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6213AE5A-72F2-6A67-2D74-FCCCB886E2DF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15050" y="3840434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AE2F9DBD-FC0E-0ED1-15B2-57B28DDEFF00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596534" y="3840434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08B5A42C-625C-8F99-2024-3D31D50B79E2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295515" y="4750949"/>
              <a:ext cx="6635186" cy="3423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Rectangle: Rounded Corners 43">
              <a:extLst>
                <a:ext uri="{FF2B5EF4-FFF2-40B4-BE49-F238E27FC236}">
                  <a16:creationId xmlns:a16="http://schemas.microsoft.com/office/drawing/2014/main" id="{F3AB4C42-3FBA-0E3F-4541-76F763E273D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56269" y="4533200"/>
              <a:ext cx="1750715" cy="51435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60</a:t>
              </a:r>
            </a:p>
          </p:txBody>
        </p:sp>
        <p:sp>
          <p:nvSpPr>
            <p:cNvPr id="45" name="Rectangle: Rounded Corners 44">
              <a:extLst>
                <a:ext uri="{FF2B5EF4-FFF2-40B4-BE49-F238E27FC236}">
                  <a16:creationId xmlns:a16="http://schemas.microsoft.com/office/drawing/2014/main" id="{79EBE262-F98C-196D-2AB4-EACB81F99C4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19237" y="4532166"/>
              <a:ext cx="1750715" cy="506034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99</a:t>
              </a:r>
            </a:p>
          </p:txBody>
        </p:sp>
        <p:sp>
          <p:nvSpPr>
            <p:cNvPr id="46" name="Rectangle: Rounded Corners 45">
              <a:extLst>
                <a:ext uri="{FF2B5EF4-FFF2-40B4-BE49-F238E27FC236}">
                  <a16:creationId xmlns:a16="http://schemas.microsoft.com/office/drawing/2014/main" id="{1CAC2F22-A239-7F74-A9DB-039877E37D4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737752" y="4541520"/>
              <a:ext cx="1750715" cy="506035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48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88C1250-F20F-C412-0D9E-2E3C05C111A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824876" y="3946161"/>
              <a:ext cx="1495104" cy="71790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655)</a:t>
              </a:r>
            </a:p>
          </p:txBody>
        </p: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CDAD4BFB-A893-8CE4-D150-DC74E425CA2A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24711" y="4180959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67BE316-C560-E952-24C2-A2AB2D35FAD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0804031" y="3956040"/>
              <a:ext cx="1495104" cy="505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18)</a:t>
              </a: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F6C961E9-5771-BBC4-0804-8DF7733EB18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603866" y="4180959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68DE962C-043E-5494-D537-CC2AA35BBA99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73204" y="5046329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D0D1B7C-E015-38CA-9E0D-0830D1CEAD41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875692" y="5161929"/>
              <a:ext cx="1495104" cy="505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0)</a:t>
              </a: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9CE38A8A-BDCD-F13F-0DC7-A202F30E9EE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675527" y="5386854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D87A7B3E-EC1B-0F66-2FE8-8684D6B4674E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15050" y="5046329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30B377D3-4EA5-B68C-9760-EEDF40E93C5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596534" y="5046329"/>
              <a:ext cx="2329" cy="6858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B388D2AA-4C05-827D-6E15-0957E78EF3B3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295515" y="5948710"/>
              <a:ext cx="6635186" cy="3423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Rectangle: Rounded Corners 56">
              <a:extLst>
                <a:ext uri="{FF2B5EF4-FFF2-40B4-BE49-F238E27FC236}">
                  <a16:creationId xmlns:a16="http://schemas.microsoft.com/office/drawing/2014/main" id="{C3F66D08-04FC-B450-45D6-D5EAB784F03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56267" y="5730964"/>
              <a:ext cx="1750715" cy="514350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60</a:t>
              </a:r>
            </a:p>
          </p:txBody>
        </p:sp>
        <p:sp>
          <p:nvSpPr>
            <p:cNvPr id="58" name="Rectangle: Rounded Corners 57">
              <a:extLst>
                <a:ext uri="{FF2B5EF4-FFF2-40B4-BE49-F238E27FC236}">
                  <a16:creationId xmlns:a16="http://schemas.microsoft.com/office/drawing/2014/main" id="{026650E4-C6A4-2082-4D3A-D1D8826C406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19235" y="5729927"/>
              <a:ext cx="1750715" cy="506034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78</a:t>
              </a:r>
            </a:p>
          </p:txBody>
        </p:sp>
        <p:sp>
          <p:nvSpPr>
            <p:cNvPr id="59" name="Rectangle: Rounded Corners 58">
              <a:extLst>
                <a:ext uri="{FF2B5EF4-FFF2-40B4-BE49-F238E27FC236}">
                  <a16:creationId xmlns:a16="http://schemas.microsoft.com/office/drawing/2014/main" id="{885630B4-6ECE-67C3-6957-187379B017B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737752" y="5739280"/>
              <a:ext cx="1750715" cy="506035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457171"/>
              <a:r>
                <a:rPr lang="en-US" sz="2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26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86757F1-CB49-3851-5C51-5BAC0E96E8D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824876" y="5161929"/>
              <a:ext cx="1495104" cy="505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22)</a:t>
              </a: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217B282A-99E2-4B62-050C-68EC0D9018AD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624711" y="5386854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A4A2F3C-0FED-0C31-DB5E-45C75C2BCAF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0804031" y="5181677"/>
              <a:ext cx="1495104" cy="505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defTabSz="457171"/>
              <a:r>
                <a:rPr lang="en-US" sz="1600" b="1" u="sng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s</a:t>
              </a:r>
              <a:endParaRPr lang="en-US" sz="16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endParaRPr>
            </a:p>
            <a:p>
              <a:pPr defTabSz="457171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ea typeface="Cambria Math" panose="02040503050406030204" pitchFamily="18" charset="0"/>
                  <a:cs typeface="Arial" panose="020B0604020202020204" pitchFamily="34" charset="0"/>
                </a:rPr>
                <a:t>Missing data (n=21)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C14C7FE3-88C4-7453-43D2-C358DBFB762A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0603866" y="5386854"/>
              <a:ext cx="20016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76642B76-81D1-E8A8-7166-2A64F75224F6}"/>
              </a:ext>
            </a:extLst>
          </p:cNvPr>
          <p:cNvSpPr txBox="1">
            <a:spLocks noChangeAspect="1"/>
          </p:cNvSpPr>
          <p:nvPr/>
        </p:nvSpPr>
        <p:spPr>
          <a:xfrm>
            <a:off x="40231" y="3561"/>
            <a:ext cx="10098179" cy="523220"/>
          </a:xfrm>
          <a:prstGeom prst="rect">
            <a:avLst/>
          </a:prstGeom>
          <a:solidFill>
            <a:schemeClr val="bg1"/>
          </a:solidFill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r>
              <a:rPr lang="en-US" sz="2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1: Flowchart of participant selection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22A19288-2202-63B6-9AF6-F64493764D1F}"/>
              </a:ext>
            </a:extLst>
          </p:cNvPr>
          <p:cNvSpPr>
            <a:spLocks noChangeAspect="1"/>
          </p:cNvSpPr>
          <p:nvPr/>
        </p:nvSpPr>
        <p:spPr>
          <a:xfrm>
            <a:off x="94265" y="4450375"/>
            <a:ext cx="2504476" cy="59537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57171"/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i3C z score</a:t>
            </a:r>
          </a:p>
          <a:p>
            <a:pPr algn="ctr" defTabSz="457171"/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Total (n=1,547)</a:t>
            </a:r>
            <a:endParaRPr 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25FE3C21-2959-676A-F4A3-BCBDA3968049}"/>
              </a:ext>
            </a:extLst>
          </p:cNvPr>
          <p:cNvSpPr>
            <a:spLocks noChangeAspect="1"/>
          </p:cNvSpPr>
          <p:nvPr/>
        </p:nvSpPr>
        <p:spPr>
          <a:xfrm>
            <a:off x="94264" y="5834455"/>
            <a:ext cx="2504476" cy="595378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57171"/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Lipoprotein Profile</a:t>
            </a:r>
          </a:p>
          <a:p>
            <a:pPr algn="ctr" defTabSz="457171"/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Total (n=307)</a:t>
            </a:r>
          </a:p>
        </p:txBody>
      </p:sp>
      <p:sp>
        <p:nvSpPr>
          <p:cNvPr id="29" name="Rectangle: Rounded Corners 28">
            <a:extLst>
              <a:ext uri="{FF2B5EF4-FFF2-40B4-BE49-F238E27FC236}">
                <a16:creationId xmlns:a16="http://schemas.microsoft.com/office/drawing/2014/main" id="{D5FB9886-EDF5-A2C8-F2E5-939E3CC651EA}"/>
              </a:ext>
            </a:extLst>
          </p:cNvPr>
          <p:cNvSpPr>
            <a:spLocks noChangeAspect="1"/>
          </p:cNvSpPr>
          <p:nvPr/>
        </p:nvSpPr>
        <p:spPr>
          <a:xfrm>
            <a:off x="53844" y="7222228"/>
            <a:ext cx="2504476" cy="59537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57171"/>
            <a:r>
              <a:rPr lang="en-US" sz="2000" b="1" dirty="0" err="1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hsCRP</a:t>
            </a:r>
            <a:endParaRPr lang="en-US" sz="2000" b="1" dirty="0">
              <a:solidFill>
                <a:prstClr val="black"/>
              </a:solidFill>
              <a:latin typeface="Arial" panose="020B0604020202020204" pitchFamily="34" charset="0"/>
              <a:ea typeface="Cambria Math" panose="02040503050406030204" pitchFamily="18" charset="0"/>
              <a:cs typeface="Arial" panose="020B0604020202020204" pitchFamily="34" charset="0"/>
            </a:endParaRPr>
          </a:p>
          <a:p>
            <a:pPr algn="ctr" defTabSz="457171"/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ea typeface="Cambria Math" panose="02040503050406030204" pitchFamily="18" charset="0"/>
                <a:cs typeface="Arial" panose="020B0604020202020204" pitchFamily="34" charset="0"/>
              </a:rPr>
              <a:t>Total (n=264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5C695F-307C-BFF0-7971-C9767FAE502D}"/>
              </a:ext>
            </a:extLst>
          </p:cNvPr>
          <p:cNvSpPr txBox="1"/>
          <p:nvPr/>
        </p:nvSpPr>
        <p:spPr>
          <a:xfrm>
            <a:off x="297180" y="8049708"/>
            <a:ext cx="1500632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ealthy Lean, defined as Body Mass Index (BMI) &lt; 85th percentile and no diabetes by ADA criteria. </a:t>
            </a:r>
          </a:p>
          <a:p>
            <a:pPr marL="285750" indent="-285750">
              <a:buFontTx/>
              <a:buChar char="-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verweight/Obesity (OW/OB), defined as BMI ≥ 85th percentile and no diabetes by ADA criteria.  </a:t>
            </a:r>
          </a:p>
          <a:p>
            <a:pPr marL="285750" indent="-285750">
              <a:buFontTx/>
              <a:buChar char="-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Youth-onset Type 2 Diabetes (Y-T2D), defined as BMI ≥ 85th percentile and diabetes by ADA criteria including A1c ≥ 6.5%, FPG ≥ 126 mg/dL, 2h-PG ≥ 200 mg/dL during a 75-g oral glucose tolerance test, or random plasma glucose ≥ 200 mg/dL with symptoms of hyperglycemia</a:t>
            </a:r>
          </a:p>
        </p:txBody>
      </p:sp>
    </p:spTree>
    <p:extLst>
      <p:ext uri="{BB962C8B-B14F-4D97-AF65-F5344CB8AC3E}">
        <p14:creationId xmlns:p14="http://schemas.microsoft.com/office/powerpoint/2010/main" val="690432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639</TotalTime>
  <Words>321</Words>
  <Application>Microsoft Office PowerPoint</Application>
  <PresentationFormat>Custom</PresentationFormat>
  <Paragraphs>5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i3C Manuscript</dc:title>
  <dc:creator>Davis, Faith (NIH/NIDDK) [F]</dc:creator>
  <cp:lastModifiedBy>Malandrino, Noemi (NIH/NIDDK) [E]</cp:lastModifiedBy>
  <cp:revision>29</cp:revision>
  <dcterms:created xsi:type="dcterms:W3CDTF">2024-07-08T14:19:43Z</dcterms:created>
  <dcterms:modified xsi:type="dcterms:W3CDTF">2025-07-27T18:33:32Z</dcterms:modified>
</cp:coreProperties>
</file>